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7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00" userDrawn="1">
          <p15:clr>
            <a:srgbClr val="A4A3A4"/>
          </p15:clr>
        </p15:guide>
        <p15:guide id="2" pos="7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300"/>
    <a:srgbClr val="C09100"/>
    <a:srgbClr val="2973B9"/>
    <a:srgbClr val="C89A00"/>
    <a:srgbClr val="F14900"/>
    <a:srgbClr val="E14403"/>
    <a:srgbClr val="2B81C2"/>
    <a:srgbClr val="F9DD00"/>
    <a:srgbClr val="FA5A06"/>
    <a:srgbClr val="43C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06"/>
    <p:restoredTop sz="88689"/>
  </p:normalViewPr>
  <p:slideViewPr>
    <p:cSldViewPr snapToGrid="0" snapToObjects="1" showGuides="1">
      <p:cViewPr varScale="1">
        <p:scale>
          <a:sx n="61" d="100"/>
          <a:sy n="61" d="100"/>
        </p:scale>
        <p:origin x="2968" y="200"/>
      </p:cViewPr>
      <p:guideLst>
        <p:guide orient="horz" pos="5400"/>
        <p:guide pos="744"/>
      </p:guideLst>
    </p:cSldViewPr>
  </p:slideViewPr>
  <p:notesTextViewPr>
    <p:cViewPr>
      <p:scale>
        <a:sx n="85" d="100"/>
        <a:sy n="85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F69FB2-9E77-AE40-9402-CD320D8F420A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53D5EE-7DDF-084A-A8E6-F948496FBD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7454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53D5EE-7DDF-084A-A8E6-F948496FBD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2198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03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72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24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070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458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73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945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370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12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44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86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237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C89762E-A46D-D64C-88D4-C75A3A3C55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0028036"/>
              </p:ext>
            </p:extLst>
          </p:nvPr>
        </p:nvGraphicFramePr>
        <p:xfrm>
          <a:off x="1187385" y="793069"/>
          <a:ext cx="4615241" cy="1281750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1767266">
                  <a:extLst>
                    <a:ext uri="{9D8B030D-6E8A-4147-A177-3AD203B41FA5}">
                      <a16:colId xmlns:a16="http://schemas.microsoft.com/office/drawing/2014/main" val="3037467691"/>
                    </a:ext>
                  </a:extLst>
                </a:gridCol>
                <a:gridCol w="1739900">
                  <a:extLst>
                    <a:ext uri="{9D8B030D-6E8A-4147-A177-3AD203B41FA5}">
                      <a16:colId xmlns:a16="http://schemas.microsoft.com/office/drawing/2014/main" val="3514751903"/>
                    </a:ext>
                  </a:extLst>
                </a:gridCol>
                <a:gridCol w="1108075">
                  <a:extLst>
                    <a:ext uri="{9D8B030D-6E8A-4147-A177-3AD203B41FA5}">
                      <a16:colId xmlns:a16="http://schemas.microsoft.com/office/drawing/2014/main" val="192516438"/>
                    </a:ext>
                  </a:extLst>
                </a:gridCol>
              </a:tblGrid>
              <a:tr h="2889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</a:p>
                  </a:txBody>
                  <a:tcPr marL="7333" marR="7333" marT="733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`-3`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3" marR="7333" marT="733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3" marR="7333" marT="7333" marB="0" anchor="ctr"/>
                </a:tc>
                <a:extLst>
                  <a:ext uri="{0D108BD9-81ED-4DB2-BD59-A6C34878D82A}">
                    <a16:rowId xmlns:a16="http://schemas.microsoft.com/office/drawing/2014/main" val="413960265"/>
                  </a:ext>
                </a:extLst>
              </a:tr>
              <a:tr h="2889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_SALK_136296_F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CTTCACTGCATCTATCTC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+R for W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99579938"/>
                  </a:ext>
                </a:extLst>
              </a:tr>
              <a:tr h="1759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_SALK_136296_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ATGGATCAATGAGTTCC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Bb1.3+R for mutan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33471340"/>
                  </a:ext>
                </a:extLst>
              </a:tr>
              <a:tr h="1759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_SALK_107515_F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AGTTGAAGGTCGGGAAG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+R for W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23493314"/>
                  </a:ext>
                </a:extLst>
              </a:tr>
              <a:tr h="1759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_SALK_107515_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TTTCCACAAACCCTTTGG 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Bb1.3+R for mutan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68008716"/>
                  </a:ext>
                </a:extLst>
              </a:tr>
              <a:tr h="1759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Bb1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33" marR="7333" marT="733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TTGCCGATTTCGGAA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03879957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5772C2D4-CD69-B94D-B82B-9AEA04A22658}"/>
              </a:ext>
            </a:extLst>
          </p:cNvPr>
          <p:cNvSpPr/>
          <p:nvPr/>
        </p:nvSpPr>
        <p:spPr>
          <a:xfrm>
            <a:off x="5317994" y="123153"/>
            <a:ext cx="15824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291F2EE-A0F9-0F48-A52E-4835A2AC7B61}"/>
              </a:ext>
            </a:extLst>
          </p:cNvPr>
          <p:cNvSpPr/>
          <p:nvPr/>
        </p:nvSpPr>
        <p:spPr>
          <a:xfrm>
            <a:off x="1718487" y="458111"/>
            <a:ext cx="58878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otyping primers used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2110868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866</TotalTime>
  <Words>77</Words>
  <Application>Microsoft Macintosh PowerPoint</Application>
  <PresentationFormat>A4 Paper (210x297 mm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Jeff</dc:creator>
  <cp:lastModifiedBy>Huang Jeff</cp:lastModifiedBy>
  <cp:revision>208</cp:revision>
  <cp:lastPrinted>2020-11-24T21:15:37Z</cp:lastPrinted>
  <dcterms:created xsi:type="dcterms:W3CDTF">2018-06-06T18:52:07Z</dcterms:created>
  <dcterms:modified xsi:type="dcterms:W3CDTF">2020-12-03T19:39:41Z</dcterms:modified>
</cp:coreProperties>
</file>